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7483"/>
    <p:restoredTop sz="94692"/>
  </p:normalViewPr>
  <p:slideViewPr>
    <p:cSldViewPr snapToGrid="0">
      <p:cViewPr varScale="1">
        <p:scale>
          <a:sx n="79" d="100"/>
          <a:sy n="79" d="100"/>
        </p:scale>
        <p:origin x="2200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B0D8923-5C29-A040-BCF4-136B17F3305A}" type="datetimeFigureOut">
              <a:rPr lang="en-US" smtClean="0"/>
              <a:t>1/21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B1563E1-3F1D-E64E-9CAD-2CF8F37E37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35697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72931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91507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3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3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7411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30163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53425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11415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5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31831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80578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90950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8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47035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8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69406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5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09391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microsoft.com/office/2007/relationships/hdphoto" Target="../media/hdphoto1.wdp"/><Relationship Id="rId7" Type="http://schemas.openxmlformats.org/officeDocument/2006/relationships/image" Target="../media/image4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microsoft.com/office/2007/relationships/hdphoto" Target="../media/hdphoto4.wdp"/><Relationship Id="rId5" Type="http://schemas.microsoft.com/office/2007/relationships/hdphoto" Target="../media/hdphoto2.wdp"/><Relationship Id="rId10" Type="http://schemas.openxmlformats.org/officeDocument/2006/relationships/image" Target="../media/image6.png"/><Relationship Id="rId4" Type="http://schemas.openxmlformats.org/officeDocument/2006/relationships/image" Target="../media/image2.png"/><Relationship Id="rId9" Type="http://schemas.microsoft.com/office/2007/relationships/hdphoto" Target="../media/hdphoto3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>
            <a:extLst>
              <a:ext uri="{FF2B5EF4-FFF2-40B4-BE49-F238E27FC236}">
                <a16:creationId xmlns:a16="http://schemas.microsoft.com/office/drawing/2014/main" id="{7E387EAF-042E-4CB1-A3E5-76A902D9FC7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rcRect t="87795" r="89126" b="1373"/>
          <a:stretch/>
        </p:blipFill>
        <p:spPr>
          <a:xfrm>
            <a:off x="367140" y="3602793"/>
            <a:ext cx="524203" cy="20542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459050B5-44CE-44CD-BD9A-BF1401DCD3C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ackgroundRemoval t="51455" b="91273" l="5079" r="66738">
                        <a14:foregroundMark x1="33548" y1="69091" x2="33476" y2="68182"/>
                        <a14:foregroundMark x1="31688" y1="54182" x2="31688" y2="52364"/>
                        <a14:foregroundMark x1="9013" y1="68182" x2="5150" y2="73455"/>
                        <a14:foregroundMark x1="41202" y1="51636" x2="50787" y2="71455"/>
                        <a14:foregroundMark x1="50787" y1="71455" x2="54006" y2="74000"/>
                        <a14:foregroundMark x1="41845" y1="69818" x2="66738" y2="77455"/>
                        <a14:foregroundMark x1="39127" y1="78909" x2="60372" y2="80545"/>
                        <a14:foregroundMark x1="60372" y1="80545" x2="64664" y2="79818"/>
                      </a14:backgroundRemoval>
                    </a14:imgEffect>
                  </a14:imgLayer>
                </a14:imgProps>
              </a:ext>
            </a:extLst>
          </a:blip>
          <a:srcRect t="48900" r="31923" b="3965"/>
          <a:stretch/>
        </p:blipFill>
        <p:spPr>
          <a:xfrm>
            <a:off x="205601" y="2070758"/>
            <a:ext cx="3281626" cy="89390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9F079288-779C-4F73-B471-5D9D46CC0870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ackgroundRemoval t="52000" b="79091" l="5079" r="68169">
                        <a14:foregroundMark x1="6509" y1="65273" x2="5150" y2="75455"/>
                        <a14:foregroundMark x1="39199" y1="54545" x2="42418" y2="54545"/>
                        <a14:foregroundMark x1="63376" y1="76000" x2="65093" y2="77091"/>
                        <a14:foregroundMark x1="67525" y1="77091" x2="67525" y2="78727"/>
                        <a14:foregroundMark x1="67811" y1="77091" x2="68169" y2="79091"/>
                      </a14:backgroundRemoval>
                    </a14:imgEffect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rcRect t="48900" r="31923" b="18976"/>
          <a:stretch/>
        </p:blipFill>
        <p:spPr>
          <a:xfrm>
            <a:off x="205601" y="1216685"/>
            <a:ext cx="3281626" cy="609212"/>
          </a:xfrm>
          <a:prstGeom prst="rect">
            <a:avLst/>
          </a:prstGeom>
        </p:spPr>
      </p:pic>
      <p:grpSp>
        <p:nvGrpSpPr>
          <p:cNvPr id="9" name="Group 8">
            <a:extLst>
              <a:ext uri="{FF2B5EF4-FFF2-40B4-BE49-F238E27FC236}">
                <a16:creationId xmlns:a16="http://schemas.microsoft.com/office/drawing/2014/main" id="{5EDA7228-D32F-40F4-B962-CA20F88CCE0F}"/>
              </a:ext>
            </a:extLst>
          </p:cNvPr>
          <p:cNvGrpSpPr/>
          <p:nvPr/>
        </p:nvGrpSpPr>
        <p:grpSpPr>
          <a:xfrm>
            <a:off x="3490421" y="1100651"/>
            <a:ext cx="3297549" cy="1192825"/>
            <a:chOff x="0" y="1030717"/>
            <a:chExt cx="10541285" cy="3497265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DEC566FD-2213-482A-A564-615DD9357C3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r="13540" b="27670"/>
            <a:stretch/>
          </p:blipFill>
          <p:spPr>
            <a:xfrm>
              <a:off x="0" y="1030717"/>
              <a:ext cx="10541285" cy="3469364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8542B146-9257-4AB1-BE19-1838EAD33A1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t="88582" r="89803" b="1752"/>
            <a:stretch/>
          </p:blipFill>
          <p:spPr>
            <a:xfrm>
              <a:off x="2003460" y="4064317"/>
              <a:ext cx="1243173" cy="463665"/>
            </a:xfrm>
            <a:prstGeom prst="rect">
              <a:avLst/>
            </a:prstGeom>
          </p:spPr>
        </p:pic>
      </p:grpSp>
      <p:sp>
        <p:nvSpPr>
          <p:cNvPr id="12" name="TextBox 11">
            <a:extLst>
              <a:ext uri="{FF2B5EF4-FFF2-40B4-BE49-F238E27FC236}">
                <a16:creationId xmlns:a16="http://schemas.microsoft.com/office/drawing/2014/main" id="{F131FEC7-A478-4E84-A0BB-AC51CBC9FFC9}"/>
              </a:ext>
            </a:extLst>
          </p:cNvPr>
          <p:cNvSpPr txBox="1"/>
          <p:nvPr/>
        </p:nvSpPr>
        <p:spPr>
          <a:xfrm>
            <a:off x="3788380" y="874037"/>
            <a:ext cx="3125892" cy="290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86" b="1" dirty="0">
                <a:latin typeface="Arial" panose="020B0604020202020204" pitchFamily="34" charset="0"/>
                <a:cs typeface="Arial" panose="020B0604020202020204" pitchFamily="34" charset="0"/>
              </a:rPr>
              <a:t>37 Candidates with and AUC &gt; 0.85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438FF44-BB7C-4103-A04A-A8A1E361762E}"/>
              </a:ext>
            </a:extLst>
          </p:cNvPr>
          <p:cNvSpPr txBox="1"/>
          <p:nvPr/>
        </p:nvSpPr>
        <p:spPr>
          <a:xfrm>
            <a:off x="3860632" y="2433940"/>
            <a:ext cx="386644" cy="290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86" dirty="0">
                <a:latin typeface="Arial" panose="020B0604020202020204" pitchFamily="34" charset="0"/>
                <a:cs typeface="Arial" panose="020B0604020202020204" pitchFamily="34" charset="0"/>
              </a:rPr>
              <a:t>P1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67A687D-DBCA-47EE-8677-4AFDE8B2F5BD}"/>
              </a:ext>
            </a:extLst>
          </p:cNvPr>
          <p:cNvSpPr txBox="1"/>
          <p:nvPr/>
        </p:nvSpPr>
        <p:spPr>
          <a:xfrm>
            <a:off x="5964780" y="3385585"/>
            <a:ext cx="386644" cy="290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86" dirty="0">
                <a:latin typeface="Arial" panose="020B0604020202020204" pitchFamily="34" charset="0"/>
                <a:cs typeface="Arial" panose="020B0604020202020204" pitchFamily="34" charset="0"/>
              </a:rPr>
              <a:t>P3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A414406-AB73-49FE-B26D-043831021D61}"/>
              </a:ext>
            </a:extLst>
          </p:cNvPr>
          <p:cNvSpPr txBox="1"/>
          <p:nvPr/>
        </p:nvSpPr>
        <p:spPr>
          <a:xfrm>
            <a:off x="523476" y="2754741"/>
            <a:ext cx="31694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solidFill>
                  <a:srgbClr val="FFC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n-arthritic Region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vs </a:t>
            </a:r>
            <a:r>
              <a:rPr lang="en-US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seased Region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540031A-CF4A-432A-8272-1A3F858AFFE1}"/>
              </a:ext>
            </a:extLst>
          </p:cNvPr>
          <p:cNvSpPr txBox="1"/>
          <p:nvPr/>
        </p:nvSpPr>
        <p:spPr>
          <a:xfrm>
            <a:off x="811648" y="874037"/>
            <a:ext cx="25931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OA Patient #3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50F22AA2-01FB-4585-B9C1-A63BC4C1708E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ackgroundRemoval t="60827" b="95276" l="7459" r="82136">
                        <a14:foregroundMark x1="7459" y1="82283" x2="8471" y2="88780"/>
                        <a14:foregroundMark x1="48711" y1="62008" x2="47330" y2="67520"/>
                        <a14:foregroundMark x1="50184" y1="63583" x2="49540" y2="77165"/>
                        <a14:foregroundMark x1="54420" y1="74803" x2="64641" y2="82480"/>
                        <a14:foregroundMark x1="70074" y1="81693" x2="81584" y2="86811"/>
                        <a14:foregroundMark x1="82228" y1="88386" x2="79926" y2="82283"/>
                        <a14:foregroundMark x1="43094" y1="80906" x2="39779" y2="60827"/>
                        <a14:foregroundMark x1="39411" y1="62598" x2="39595" y2="65354"/>
                      </a14:backgroundRemoval>
                    </a14:imgEffect>
                  </a14:imgLayer>
                </a14:imgProps>
              </a:ext>
            </a:extLst>
          </a:blip>
          <a:srcRect t="57366" r="16134"/>
          <a:stretch/>
        </p:blipFill>
        <p:spPr>
          <a:xfrm>
            <a:off x="101789" y="2958979"/>
            <a:ext cx="3471575" cy="829668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1264866C-60A6-40C7-970B-4A73B9740684}"/>
              </a:ext>
            </a:extLst>
          </p:cNvPr>
          <p:cNvSpPr txBox="1"/>
          <p:nvPr/>
        </p:nvSpPr>
        <p:spPr>
          <a:xfrm>
            <a:off x="352617" y="874037"/>
            <a:ext cx="343364" cy="3561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14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0F96646-4946-4558-80FE-F3A7079A2220}"/>
              </a:ext>
            </a:extLst>
          </p:cNvPr>
          <p:cNvSpPr txBox="1"/>
          <p:nvPr/>
        </p:nvSpPr>
        <p:spPr>
          <a:xfrm>
            <a:off x="352617" y="1818228"/>
            <a:ext cx="343364" cy="3561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14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6784A1D0-0014-4575-9044-1F5BBE17E758}"/>
              </a:ext>
            </a:extLst>
          </p:cNvPr>
          <p:cNvSpPr txBox="1"/>
          <p:nvPr/>
        </p:nvSpPr>
        <p:spPr>
          <a:xfrm>
            <a:off x="920756" y="1818228"/>
            <a:ext cx="23748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op 500 Segmentation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3AB05F6-3E96-47A3-8E68-E67AF1DD2A4A}"/>
              </a:ext>
            </a:extLst>
          </p:cNvPr>
          <p:cNvSpPr txBox="1"/>
          <p:nvPr/>
        </p:nvSpPr>
        <p:spPr>
          <a:xfrm>
            <a:off x="352617" y="2715228"/>
            <a:ext cx="343364" cy="3561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14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95827C01-3955-4C6B-B94E-4A4F7FA6A2F4}"/>
              </a:ext>
            </a:extLst>
          </p:cNvPr>
          <p:cNvSpPr txBox="1"/>
          <p:nvPr/>
        </p:nvSpPr>
        <p:spPr>
          <a:xfrm>
            <a:off x="3532423" y="844760"/>
            <a:ext cx="343364" cy="3561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14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019A15E-5230-4D38-9343-14C288233151}"/>
              </a:ext>
            </a:extLst>
          </p:cNvPr>
          <p:cNvSpPr txBox="1"/>
          <p:nvPr/>
        </p:nvSpPr>
        <p:spPr>
          <a:xfrm>
            <a:off x="3532423" y="2399189"/>
            <a:ext cx="330540" cy="3561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14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87994E64-583A-4E2A-B409-54264E3B12F8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ackgroundRemoval t="9327" b="91372" l="4322" r="96430">
                        <a14:foregroundMark x1="50620" y1="14663" x2="50620" y2="14663"/>
                        <a14:foregroundMark x1="50395" y1="14364" x2="53251" y2="69626"/>
                        <a14:foregroundMark x1="51484" y1="83142" x2="49042" y2="86085"/>
                        <a14:foregroundMark x1="53927" y1="19052" x2="43442" y2="10623"/>
                        <a14:foregroundMark x1="43442" y1="10623" x2="31567" y2="9327"/>
                        <a14:foregroundMark x1="31567" y1="9327" x2="20030" y2="13067"/>
                        <a14:foregroundMark x1="20030" y1="13067" x2="12364" y2="29277"/>
                        <a14:foregroundMark x1="12364" y1="29277" x2="9620" y2="46783"/>
                        <a14:foregroundMark x1="9620" y1="46783" x2="11124" y2="62993"/>
                        <a14:foregroundMark x1="11124" y1="62993" x2="19203" y2="74414"/>
                        <a14:foregroundMark x1="19203" y1="74414" x2="33183" y2="81845"/>
                        <a14:foregroundMark x1="33183" y1="81845" x2="46787" y2="82843"/>
                        <a14:foregroundMark x1="46787" y1="82843" x2="49042" y2="82544"/>
                        <a14:foregroundMark x1="31567" y1="11721" x2="36640" y2="9925"/>
                        <a14:foregroundMark x1="9395" y1="40200" x2="4322" y2="47581"/>
                        <a14:foregroundMark x1="84705" y1="43142" x2="84292" y2="53167"/>
                        <a14:foregroundMark x1="87599" y1="60200" x2="93574" y2="54613"/>
                        <a14:foregroundMark x1="75874" y1="11970" x2="61669" y2="9327"/>
                        <a14:foregroundMark x1="96467" y1="51970" x2="96242" y2="40200"/>
                        <a14:foregroundMark x1="30440" y1="89327" x2="38407" y2="90175"/>
                        <a14:foregroundMark x1="60353" y1="89875" x2="67230" y2="90474"/>
                        <a14:foregroundMark x1="16723" y1="84888" x2="41601" y2="89027"/>
                        <a14:foregroundMark x1="41601" y1="89027" x2="49944" y2="86933"/>
                        <a14:foregroundMark x1="58136" y1="90175" x2="70237" y2="91072"/>
                        <a14:foregroundMark x1="70237" y1="91072" x2="81398" y2="87132"/>
                        <a14:foregroundMark x1="81398" y1="87132" x2="90492" y2="77855"/>
                        <a14:foregroundMark x1="90492" y1="77855" x2="68546" y2="91372"/>
                      </a14:backgroundRemoval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7290" b="8635"/>
          <a:stretch/>
        </p:blipFill>
        <p:spPr>
          <a:xfrm>
            <a:off x="4035782" y="2332789"/>
            <a:ext cx="2192202" cy="138871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2B85EFFA-B22F-7B10-6A7A-0AF9E57FB2E7}"/>
              </a:ext>
            </a:extLst>
          </p:cNvPr>
          <p:cNvSpPr txBox="1"/>
          <p:nvPr/>
        </p:nvSpPr>
        <p:spPr>
          <a:xfrm>
            <a:off x="111330" y="4169614"/>
            <a:ext cx="6632157" cy="22467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/>
            <a:r>
              <a:rPr lang="en-US" sz="14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l Figure 7: Tissue Segmentation and candidate ion generation from additional OA Patients.  </a:t>
            </a: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OA Patient 3 (P3) (A) was used to generate candidate features. (B) The top 500 most abundant m/z features were used to automatically generate tissue regions. (C) Extraction of the tissue regions containing sclerotic 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diseased</a:t>
            </a: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bone and non-arthritic region allowed for feature analysis. (D) ROC analysis between the extracted regions resulted in 37 candidate ions that described the difference between the independent regions with an AUROC of &gt; 0.85. (E) Comparison of the 37 specific ions identified from patient #3 shared 19 ions in common with </a:t>
            </a:r>
            <a:r>
              <a:rPr lang="en-US" sz="140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candidates generated</a:t>
            </a:r>
            <a:r>
              <a:rPr lang="en-US" sz="140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 </a:t>
            </a: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rom those identified using representative patient #1.</a:t>
            </a:r>
            <a:endParaRPr lang="en-US" sz="14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1192919-2E31-8887-23A5-445408A50C6A}"/>
              </a:ext>
            </a:extLst>
          </p:cNvPr>
          <p:cNvSpPr txBox="1"/>
          <p:nvPr/>
        </p:nvSpPr>
        <p:spPr>
          <a:xfrm>
            <a:off x="111330" y="237365"/>
            <a:ext cx="346065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ea typeface="Times New Roman" panose="02020603050405020304" pitchFamily="18" charset="0"/>
              </a:rPr>
              <a:t>Supplemental Figure 7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27147599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</TotalTime>
  <Words>160</Words>
  <Application>Microsoft Macintosh PowerPoint</Application>
  <PresentationFormat>Letter Paper (8.5x11 in)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harlie Schurman</dc:creator>
  <cp:lastModifiedBy>Birgit Schilling</cp:lastModifiedBy>
  <cp:revision>19</cp:revision>
  <dcterms:created xsi:type="dcterms:W3CDTF">2024-10-28T17:59:57Z</dcterms:created>
  <dcterms:modified xsi:type="dcterms:W3CDTF">2025-01-22T03:35:16Z</dcterms:modified>
</cp:coreProperties>
</file>